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0824F6-80B3-4FDA-9FF4-2D8EB7C022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E4377B-4B93-4B83-8745-7B1FED1FFE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E2C11B-F33F-46B5-9A3F-317181C9CB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C44120-4F15-4BD1-ACA8-E872982915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B28D66-95BB-43BF-A56B-49D18E7F7D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D18AE3-F0D4-41F5-B077-5FF0FC7D4C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2F770-4A84-49EE-B35A-AA42138E47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BDD81C-ED5F-4684-9502-99D8191F78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A030A2-6C98-4219-86DE-3544DA8C93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BD1BAB-1511-4CD0-8CE4-D27B717157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D5916-47F3-44F3-9285-9F89D58C1E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83CCD9-B7DD-4DE9-A6BA-BE3213854E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9B152A-869C-4A13-B9A9-4CC4139E0E5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304920" y="962640"/>
            <a:ext cx="853416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Table S2.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tatistical significance of the enhancement  of  AraC-induced total cell death by CA, D2 or thei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                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ombination. Cell death was assessed by Annexin V staining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52280" y="1828800"/>
          <a:ext cx="8839440" cy="1676520"/>
        </p:xfrm>
        <a:graphic>
          <a:graphicData uri="http://schemas.openxmlformats.org/drawingml/2006/table">
            <a:tbl>
              <a:tblPr/>
              <a:tblGrid>
                <a:gridCol w="1944720"/>
                <a:gridCol w="911160"/>
                <a:gridCol w="685800"/>
                <a:gridCol w="954360"/>
                <a:gridCol w="838080"/>
                <a:gridCol w="203040"/>
                <a:gridCol w="911520"/>
                <a:gridCol w="561960"/>
                <a:gridCol w="917280"/>
                <a:gridCol w="911520"/>
              </a:tblGrid>
              <a:tr h="239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4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ML ex vivo cell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 gridSpan="4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rmal BM cell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39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verage±S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verag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39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reatment group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tal deat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s Ara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s AraC-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s AraC-D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otal deat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s Ara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s AraC-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s AraC-D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7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ra-C-100 nM-Cotnro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.7% ± 4.7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9.4% ± 5.9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39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ra-C-72hr-CA-96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8.7% ± 7.3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3.4% ±9.5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3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39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ra-C-72hr-1-D2-96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9.4% ± 7.2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3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6.6% ± 5.9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39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ra-C-72hr-CA+1-D2-96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7.8% ± 6.4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5.3% ± 6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7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29T17:47:34Z</dcterms:created>
  <dc:creator>UmdNJ</dc:creator>
  <dc:description/>
  <dc:language>en-US</dc:language>
  <cp:lastModifiedBy>Wang, Xuening</cp:lastModifiedBy>
  <dcterms:modified xsi:type="dcterms:W3CDTF">2016-03-21T23:26:45Z</dcterms:modified>
  <cp:revision>17</cp:revision>
  <dc:subject/>
  <dc:title>Slide 1</dc:title>
</cp:coreProperties>
</file>